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3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_rels/presentation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26.xml.rels" ContentType="application/vnd.openxmlformats-package.relationships+xml"/>
  <Override PartName="/ppt/slideLayouts/slideLayout29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media/image1.wmf" ContentType="image/x-wmf"/>
  <Override PartName="/ppt/media/image2.png" ContentType="image/png"/>
  <Override PartName="/ppt/media/image3.png" ContentType="image/png"/>
  <Override PartName="/ppt/media/image4.jpeg" ContentType="image/jpeg"/>
  <Override PartName="/ppt/media/image5.jpeg" ContentType="image/jpeg"/>
  <Override PartName="/ppt/media/image6.wmf" ContentType="image/x-wmf"/>
  <Override PartName="/ppt/media/image7.wmf" ContentType="image/x-wmf"/>
  <Override PartName="/ppt/media/image8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</p:sldMasterIdLst>
  <p:sldIdLst>
    <p:sldId id="256" r:id="rId5"/>
    <p:sldId id="257" r:id="rId6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545831-F2F4-405B-988A-8C907E6ACCA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7AD50A-D7DF-4289-8FB0-1D249E5FF64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76DD1A-40A8-40FC-BDB2-86EE0D3B463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A2C7BE-625B-4952-BF2A-62AC6D4A3A3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9B9875E-3BF0-4961-9B00-7859371BB11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EFB0A2D-0387-4AA6-B681-ED2C347352F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B5BF565-2D66-4D9E-9168-CC9D4F6EF7E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90717AD-D004-4B72-8847-A90894114B4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47D9475-5574-4A95-9BB5-00C4D73596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3F5B779-84BF-4FC5-A884-27D1B9440A1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78A5E14-9268-4AC7-9A6D-967E6883EE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A485A1-5E0B-4AD8-8F77-71F931D9B52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9F3B227-F90C-47E0-9703-F2E7BE6910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860B20C-8BFC-4213-AA7E-2C4C4E91E4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B7E6A90-23E5-4BA7-AC98-764F7152673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44C55BF-5E71-4286-B923-2B87B198C29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1DE428F-48EB-45C2-8F8B-09F8176177B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D966CFE-E6B1-42DC-B797-9D2CF01832F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A968325B-1228-4569-A476-9208EA1140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0AE1A3BC-2227-4F62-B597-87EC39F851B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DF8AB62-8AEC-4092-B794-BF574948A1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8535847A-688A-45F5-8A9F-E56A8BBA657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9EDE2E-74B5-48B8-9D03-8C3B244ED88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B2B95AB-2AD4-4D42-A98C-7E2FFB525E6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D40944A4-160F-440B-B17D-E14BC087D7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F4802A19-7A89-456E-8F68-CB2EBC7E95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F5C4E3DF-458B-4C58-BBD2-49F91244B8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C739EF77-46E2-404A-A0DF-5E8E72E79E3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A57FEAE4-E890-4E37-8C33-D842253CFEE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8F12A2F-3253-4E77-B92F-7D5E7C8ACE3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6A583E-0806-4813-A817-46E0DFECDDC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D28929-54EC-4749-B7C6-1DF18A12A1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DACFDD-F4EF-4958-A65E-AAB37CD4CD4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53822B-86DB-47FD-ADA1-B096D9983F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28D919-ABC5-4AF4-A17A-05FE3B2079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2679F1-E274-4760-8820-2086516C03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457200" indent="4572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9144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371600" indent="-4572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1828800" indent="-9144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1828800" indent="-9144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1828800" indent="-9144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D9C44B1-6BB1-4599-95C2-A2EBEFE6A9C4}" type="datetime"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26/8/29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0773F73-244D-41A9-9EB2-69973DB22C25}" type="slidenum"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457200" indent="4572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9144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371600" indent="-4572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1828800" indent="-9144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1828800" indent="-9144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1828800" indent="-9144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8009F39-3265-4B57-B606-74F709DE1322}" type="slidenum">
              <a:rPr b="0" lang="en-US" sz="14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457200" indent="4572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9144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371600" indent="-4572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1828800" indent="-9144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1828800" indent="-9144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1828800" indent="-9144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PlaceHolder 3"/>
          <p:cNvSpPr>
            <a:spLocks noGrp="1"/>
          </p:cNvSpPr>
          <p:nvPr>
            <p:ph type="dt" idx="7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PlaceHolder 4"/>
          <p:cNvSpPr>
            <a:spLocks noGrp="1"/>
          </p:cNvSpPr>
          <p:nvPr>
            <p:ph type="ftr" idx="8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PlaceHolder 5"/>
          <p:cNvSpPr>
            <a:spLocks noGrp="1"/>
          </p:cNvSpPr>
          <p:nvPr>
            <p:ph type="sldNum" idx="9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B6ACD1E-C46D-42B6-87B2-8F31278DA21A}" type="slidenum">
              <a:rPr b="0" lang="en-US" sz="14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wmf"/><Relationship Id="rId7" Type="http://schemas.openxmlformats.org/officeDocument/2006/relationships/image" Target="../media/image7.wmf"/><Relationship Id="rId8" Type="http://schemas.openxmlformats.org/officeDocument/2006/relationships/image" Target="../media/image8.wmf"/><Relationship Id="rId9" Type="http://schemas.openxmlformats.org/officeDocument/2006/relationships/slideLayout" Target="../slideLayouts/slideLayout1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Text Box 2"/>
          <p:cNvSpPr/>
          <p:nvPr/>
        </p:nvSpPr>
        <p:spPr>
          <a:xfrm>
            <a:off x="3675240" y="1486080"/>
            <a:ext cx="711000" cy="296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Text Box 3"/>
          <p:cNvSpPr/>
          <p:nvPr/>
        </p:nvSpPr>
        <p:spPr>
          <a:xfrm>
            <a:off x="3813120" y="1068480"/>
            <a:ext cx="542880" cy="295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PARP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PlaceHolder 1"/>
          <p:cNvSpPr>
            <a:spLocks noGrp="1"/>
          </p:cNvSpPr>
          <p:nvPr>
            <p:ph type="title"/>
          </p:nvPr>
        </p:nvSpPr>
        <p:spPr>
          <a:xfrm>
            <a:off x="6838560" y="571680"/>
            <a:ext cx="1685880" cy="34272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HT-29</a:t>
            </a:r>
            <a:endParaRPr b="0" lang="en-US" sz="1200" spc="-1" strike="noStrike">
              <a:solidFill>
                <a:srgbClr val="000000"/>
              </a:solidFill>
              <a:latin typeface="Calibri Light"/>
            </a:endParaRPr>
          </a:p>
        </p:txBody>
      </p:sp>
      <p:pic>
        <p:nvPicPr>
          <p:cNvPr id="126" name="Object 5" descr=""/>
          <p:cNvPicPr/>
          <p:nvPr/>
        </p:nvPicPr>
        <p:blipFill>
          <a:blip r:embed="rId1"/>
          <a:stretch/>
        </p:blipFill>
        <p:spPr>
          <a:xfrm>
            <a:off x="3867120" y="2457360"/>
            <a:ext cx="2095560" cy="2286000"/>
          </a:xfrm>
          <a:prstGeom prst="rect">
            <a:avLst/>
          </a:prstGeom>
          <a:ln w="0">
            <a:noFill/>
          </a:ln>
        </p:spPr>
      </p:pic>
      <p:sp>
        <p:nvSpPr>
          <p:cNvPr id="127" name="Rectangle 6"/>
          <p:cNvSpPr/>
          <p:nvPr/>
        </p:nvSpPr>
        <p:spPr>
          <a:xfrm>
            <a:off x="4210200" y="628560"/>
            <a:ext cx="2100240" cy="400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44546a"/>
                </a:solidFill>
                <a:latin typeface="Times New Roman"/>
                <a:ea typeface="宋体"/>
              </a:rPr>
              <a:t>HCT-11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Text Box 7"/>
          <p:cNvSpPr/>
          <p:nvPr/>
        </p:nvSpPr>
        <p:spPr>
          <a:xfrm>
            <a:off x="6316560" y="1025640"/>
            <a:ext cx="542880" cy="296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PARP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Rectangle 8"/>
          <p:cNvSpPr/>
          <p:nvPr/>
        </p:nvSpPr>
        <p:spPr>
          <a:xfrm>
            <a:off x="3809880" y="457200"/>
            <a:ext cx="1717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Times New Roman"/>
                <a:ea typeface="宋体"/>
              </a:rPr>
              <a:t>A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Rectangle 9"/>
          <p:cNvSpPr/>
          <p:nvPr/>
        </p:nvSpPr>
        <p:spPr>
          <a:xfrm>
            <a:off x="4506840" y="1797120"/>
            <a:ext cx="1540080" cy="57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8600" rIns="48600" tIns="24480" bIns="24480" anchor="t">
            <a:noAutofit/>
          </a:bodyPr>
          <a:p>
            <a:pPr algn="just">
              <a:lnSpc>
                <a:spcPct val="14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－       －       ＋      ＋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4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－       ＋       －      ＋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Rectangle 10"/>
          <p:cNvSpPr/>
          <p:nvPr/>
        </p:nvSpPr>
        <p:spPr>
          <a:xfrm>
            <a:off x="3324240" y="1771560"/>
            <a:ext cx="1111320" cy="571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8600" rIns="48600" tIns="24480" bIns="24480" anchor="t">
            <a:noAutofit/>
          </a:bodyPr>
          <a:p>
            <a:pPr algn="r"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宋体"/>
              </a:rPr>
              <a:t>Mithramyc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000" spc="-1" strike="noStrike">
                <a:solidFill>
                  <a:srgbClr val="000000"/>
                </a:solidFill>
                <a:latin typeface="Times New Roman"/>
                <a:ea typeface="宋体"/>
              </a:rPr>
              <a:t> </a:t>
            </a: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宋体"/>
              </a:rPr>
              <a:t> </a:t>
            </a: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宋体"/>
              </a:rPr>
              <a:t>NaB(2m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Rectangle 11"/>
          <p:cNvSpPr/>
          <p:nvPr/>
        </p:nvSpPr>
        <p:spPr>
          <a:xfrm>
            <a:off x="6989760" y="1728720"/>
            <a:ext cx="1538280" cy="571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8600" rIns="48600" tIns="24480" bIns="24480" anchor="t">
            <a:noAutofit/>
          </a:bodyPr>
          <a:p>
            <a:pPr algn="just">
              <a:lnSpc>
                <a:spcPct val="14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－       －       ＋       ＋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4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－       ＋       －       ＋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Rectangle 12"/>
          <p:cNvSpPr/>
          <p:nvPr/>
        </p:nvSpPr>
        <p:spPr>
          <a:xfrm>
            <a:off x="5838840" y="1714680"/>
            <a:ext cx="1111320" cy="57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8600" rIns="48600" tIns="24480" bIns="24480" anchor="t">
            <a:noAutofit/>
          </a:bodyPr>
          <a:p>
            <a:pPr algn="r"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宋体"/>
              </a:rPr>
              <a:t>Mithramyc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000" spc="-1" strike="noStrike">
                <a:solidFill>
                  <a:srgbClr val="000000"/>
                </a:solidFill>
                <a:latin typeface="Times New Roman"/>
                <a:ea typeface="宋体"/>
              </a:rPr>
              <a:t> </a:t>
            </a:r>
            <a:r>
              <a:rPr b="1" lang="it-IT" sz="1000" spc="-1" strike="noStrike">
                <a:solidFill>
                  <a:srgbClr val="000000"/>
                </a:solidFill>
                <a:latin typeface="Arial"/>
                <a:ea typeface="宋体"/>
              </a:rPr>
              <a:t> </a:t>
            </a: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宋体"/>
              </a:rPr>
              <a:t>NaB(2m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Text Box 13"/>
          <p:cNvSpPr/>
          <p:nvPr/>
        </p:nvSpPr>
        <p:spPr>
          <a:xfrm>
            <a:off x="6170760" y="1436760"/>
            <a:ext cx="712800" cy="295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5" name="Picture 14" descr="PARP-1"/>
          <p:cNvPicPr/>
          <p:nvPr/>
        </p:nvPicPr>
        <p:blipFill>
          <a:blip r:embed="rId2"/>
          <a:stretch/>
        </p:blipFill>
        <p:spPr>
          <a:xfrm>
            <a:off x="6864480" y="900000"/>
            <a:ext cx="1657080" cy="42408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136" name="Picture 15" descr="PARP-22"/>
          <p:cNvPicPr/>
          <p:nvPr/>
        </p:nvPicPr>
        <p:blipFill>
          <a:blip r:embed="rId3"/>
          <a:stretch/>
        </p:blipFill>
        <p:spPr>
          <a:xfrm>
            <a:off x="4395960" y="979560"/>
            <a:ext cx="1657080" cy="39528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137" name="Picture 16" descr="GAPDH-2"/>
          <p:cNvPicPr/>
          <p:nvPr/>
        </p:nvPicPr>
        <p:blipFill>
          <a:blip r:embed="rId4"/>
          <a:stretch/>
        </p:blipFill>
        <p:spPr>
          <a:xfrm>
            <a:off x="4392720" y="1486080"/>
            <a:ext cx="1657080" cy="28548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138" name="Picture 17" descr="GAPDH-1"/>
          <p:cNvPicPr/>
          <p:nvPr/>
        </p:nvPicPr>
        <p:blipFill>
          <a:blip r:embed="rId5"/>
          <a:stretch/>
        </p:blipFill>
        <p:spPr>
          <a:xfrm>
            <a:off x="6870600" y="1428840"/>
            <a:ext cx="1657440" cy="25884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139" name="Object 18" descr=""/>
          <p:cNvPicPr/>
          <p:nvPr/>
        </p:nvPicPr>
        <p:blipFill>
          <a:blip r:embed="rId6"/>
          <a:stretch/>
        </p:blipFill>
        <p:spPr>
          <a:xfrm>
            <a:off x="6324480" y="2400480"/>
            <a:ext cx="2208240" cy="2408040"/>
          </a:xfrm>
          <a:prstGeom prst="rect">
            <a:avLst/>
          </a:prstGeom>
          <a:ln w="0">
            <a:noFill/>
          </a:ln>
        </p:spPr>
      </p:pic>
      <p:grpSp>
        <p:nvGrpSpPr>
          <p:cNvPr id="140" name="Group 19"/>
          <p:cNvGrpSpPr/>
          <p:nvPr/>
        </p:nvGrpSpPr>
        <p:grpSpPr>
          <a:xfrm>
            <a:off x="3753000" y="4572000"/>
            <a:ext cx="2342880" cy="2286000"/>
            <a:chOff x="3753000" y="4572000"/>
            <a:chExt cx="2342880" cy="2286000"/>
          </a:xfrm>
        </p:grpSpPr>
        <p:pic>
          <p:nvPicPr>
            <p:cNvPr id="141" name="Object 20" descr=""/>
            <p:cNvPicPr/>
            <p:nvPr/>
          </p:nvPicPr>
          <p:blipFill>
            <a:blip r:embed="rId7"/>
            <a:stretch/>
          </p:blipFill>
          <p:spPr>
            <a:xfrm>
              <a:off x="3753000" y="4572000"/>
              <a:ext cx="2342880" cy="228600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42" name=""/>
            <p:cNvGrpSpPr/>
            <p:nvPr/>
          </p:nvGrpSpPr>
          <p:grpSpPr>
            <a:xfrm>
              <a:off x="4464000" y="5287680"/>
              <a:ext cx="360" cy="331560"/>
              <a:chOff x="4464000" y="5287680"/>
              <a:chExt cx="360" cy="331560"/>
            </a:xfrm>
          </p:grpSpPr>
          <p:sp>
            <p:nvSpPr>
              <p:cNvPr id="143" name="Line 21"/>
              <p:cNvSpPr/>
              <p:nvPr/>
            </p:nvSpPr>
            <p:spPr>
              <a:xfrm>
                <a:off x="4464000" y="5287680"/>
                <a:ext cx="0" cy="33156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4" name=""/>
              <p:cNvSpPr txBox="1"/>
              <p:nvPr/>
            </p:nvSpPr>
            <p:spPr>
              <a:xfrm>
                <a:off x="4464000" y="5287680"/>
                <a:ext cx="360" cy="331560"/>
              </a:xfrm>
              <a:prstGeom prst="rect">
                <a:avLst/>
              </a:prstGeom>
              <a:noFill/>
              <a:ln w="0">
                <a:noFill/>
              </a:ln>
            </p:spPr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45" name=""/>
            <p:cNvGrpSpPr/>
            <p:nvPr/>
          </p:nvGrpSpPr>
          <p:grpSpPr>
            <a:xfrm>
              <a:off x="5698440" y="5017680"/>
              <a:ext cx="360" cy="148320"/>
              <a:chOff x="5698440" y="5017680"/>
              <a:chExt cx="360" cy="148320"/>
            </a:xfrm>
          </p:grpSpPr>
          <p:sp>
            <p:nvSpPr>
              <p:cNvPr id="146" name="Line 22"/>
              <p:cNvSpPr/>
              <p:nvPr/>
            </p:nvSpPr>
            <p:spPr>
              <a:xfrm>
                <a:off x="5698440" y="5017680"/>
                <a:ext cx="0" cy="14832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7" name=""/>
              <p:cNvSpPr txBox="1"/>
              <p:nvPr/>
            </p:nvSpPr>
            <p:spPr>
              <a:xfrm>
                <a:off x="5698440" y="5017680"/>
                <a:ext cx="360" cy="148320"/>
              </a:xfrm>
              <a:prstGeom prst="rect">
                <a:avLst/>
              </a:prstGeom>
              <a:noFill/>
              <a:ln w="0">
                <a:noFill/>
              </a:ln>
            </p:spPr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48" name=""/>
            <p:cNvGrpSpPr/>
            <p:nvPr/>
          </p:nvGrpSpPr>
          <p:grpSpPr>
            <a:xfrm>
              <a:off x="4875480" y="5017680"/>
              <a:ext cx="360" cy="331560"/>
              <a:chOff x="4875480" y="5017680"/>
              <a:chExt cx="360" cy="331560"/>
            </a:xfrm>
          </p:grpSpPr>
          <p:sp>
            <p:nvSpPr>
              <p:cNvPr id="149" name="Line 23"/>
              <p:cNvSpPr/>
              <p:nvPr/>
            </p:nvSpPr>
            <p:spPr>
              <a:xfrm>
                <a:off x="4875480" y="5017680"/>
                <a:ext cx="0" cy="33156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0" name=""/>
              <p:cNvSpPr txBox="1"/>
              <p:nvPr/>
            </p:nvSpPr>
            <p:spPr>
              <a:xfrm>
                <a:off x="4875480" y="5017680"/>
                <a:ext cx="360" cy="331560"/>
              </a:xfrm>
              <a:prstGeom prst="rect">
                <a:avLst/>
              </a:prstGeom>
              <a:noFill/>
              <a:ln w="0">
                <a:noFill/>
              </a:ln>
            </p:spPr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51" name=""/>
            <p:cNvGrpSpPr/>
            <p:nvPr/>
          </p:nvGrpSpPr>
          <p:grpSpPr>
            <a:xfrm>
              <a:off x="4868640" y="5017680"/>
              <a:ext cx="836640" cy="360"/>
              <a:chOff x="4868640" y="5017680"/>
              <a:chExt cx="836640" cy="360"/>
            </a:xfrm>
          </p:grpSpPr>
          <p:sp>
            <p:nvSpPr>
              <p:cNvPr id="152" name="Line 24"/>
              <p:cNvSpPr/>
              <p:nvPr/>
            </p:nvSpPr>
            <p:spPr>
              <a:xfrm flipH="1">
                <a:off x="4868640" y="5017680"/>
                <a:ext cx="8366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3" name=""/>
              <p:cNvSpPr txBox="1"/>
              <p:nvPr/>
            </p:nvSpPr>
            <p:spPr>
              <a:xfrm>
                <a:off x="4868640" y="5017680"/>
                <a:ext cx="836640" cy="360"/>
              </a:xfrm>
              <a:prstGeom prst="rect">
                <a:avLst/>
              </a:prstGeom>
              <a:noFill/>
              <a:ln w="0">
                <a:noFill/>
              </a:ln>
            </p:spPr>
            <p:txBody>
              <a:bodyPr lIns="90000" rIns="90000" tIns="-46440" bIns="-464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54" name=""/>
            <p:cNvGrpSpPr/>
            <p:nvPr/>
          </p:nvGrpSpPr>
          <p:grpSpPr>
            <a:xfrm>
              <a:off x="4464000" y="5287680"/>
              <a:ext cx="407880" cy="360"/>
              <a:chOff x="4464000" y="5287680"/>
              <a:chExt cx="407880" cy="360"/>
            </a:xfrm>
          </p:grpSpPr>
          <p:sp>
            <p:nvSpPr>
              <p:cNvPr id="155" name="Line 25"/>
              <p:cNvSpPr/>
              <p:nvPr/>
            </p:nvSpPr>
            <p:spPr>
              <a:xfrm>
                <a:off x="4464000" y="5287680"/>
                <a:ext cx="407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6" name=""/>
              <p:cNvSpPr txBox="1"/>
              <p:nvPr/>
            </p:nvSpPr>
            <p:spPr>
              <a:xfrm>
                <a:off x="4464000" y="5287680"/>
                <a:ext cx="407880" cy="360"/>
              </a:xfrm>
              <a:prstGeom prst="rect">
                <a:avLst/>
              </a:prstGeom>
              <a:noFill/>
              <a:ln w="0">
                <a:noFill/>
              </a:ln>
            </p:spPr>
            <p:txBody>
              <a:bodyPr lIns="90000" rIns="90000" tIns="-46440" bIns="-464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57" name="Rectangle 26"/>
            <p:cNvSpPr/>
            <p:nvPr/>
          </p:nvSpPr>
          <p:spPr>
            <a:xfrm>
              <a:off x="5147640" y="4872600"/>
              <a:ext cx="278640" cy="11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宋体"/>
                  <a:ea typeface="宋体"/>
                </a:rPr>
                <a:t>**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" name="Rectangle 27"/>
            <p:cNvSpPr/>
            <p:nvPr/>
          </p:nvSpPr>
          <p:spPr>
            <a:xfrm>
              <a:off x="4533840" y="5142240"/>
              <a:ext cx="278640" cy="11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宋体"/>
                  <a:ea typeface="宋体"/>
                </a:rPr>
                <a:t>**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59" name="Group 37"/>
          <p:cNvGrpSpPr/>
          <p:nvPr/>
        </p:nvGrpSpPr>
        <p:grpSpPr>
          <a:xfrm>
            <a:off x="6383160" y="4400640"/>
            <a:ext cx="2284560" cy="2131920"/>
            <a:chOff x="6383160" y="4400640"/>
            <a:chExt cx="2284560" cy="2131920"/>
          </a:xfrm>
        </p:grpSpPr>
        <p:pic>
          <p:nvPicPr>
            <p:cNvPr id="160" name="Object 29" descr=""/>
            <p:cNvPicPr/>
            <p:nvPr/>
          </p:nvPicPr>
          <p:blipFill>
            <a:blip r:embed="rId8"/>
            <a:stretch/>
          </p:blipFill>
          <p:spPr>
            <a:xfrm>
              <a:off x="6383160" y="4400640"/>
              <a:ext cx="2284560" cy="21319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61" name=""/>
            <p:cNvGrpSpPr/>
            <p:nvPr/>
          </p:nvGrpSpPr>
          <p:grpSpPr>
            <a:xfrm>
              <a:off x="7077240" y="5045760"/>
              <a:ext cx="360" cy="322560"/>
              <a:chOff x="7077240" y="5045760"/>
              <a:chExt cx="360" cy="322560"/>
            </a:xfrm>
          </p:grpSpPr>
          <p:sp>
            <p:nvSpPr>
              <p:cNvPr id="162" name="Line 30"/>
              <p:cNvSpPr/>
              <p:nvPr/>
            </p:nvSpPr>
            <p:spPr>
              <a:xfrm>
                <a:off x="7077240" y="5045760"/>
                <a:ext cx="0" cy="32256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3" name=""/>
              <p:cNvSpPr txBox="1"/>
              <p:nvPr/>
            </p:nvSpPr>
            <p:spPr>
              <a:xfrm>
                <a:off x="7077240" y="5045760"/>
                <a:ext cx="360" cy="322560"/>
              </a:xfrm>
              <a:prstGeom prst="rect">
                <a:avLst/>
              </a:prstGeom>
              <a:noFill/>
              <a:ln w="0">
                <a:noFill/>
              </a:ln>
            </p:spPr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64" name=""/>
            <p:cNvGrpSpPr/>
            <p:nvPr/>
          </p:nvGrpSpPr>
          <p:grpSpPr>
            <a:xfrm>
              <a:off x="8274960" y="4881600"/>
              <a:ext cx="360" cy="137880"/>
              <a:chOff x="8274960" y="4881600"/>
              <a:chExt cx="360" cy="137880"/>
            </a:xfrm>
          </p:grpSpPr>
          <p:sp>
            <p:nvSpPr>
              <p:cNvPr id="165" name="Line 31"/>
              <p:cNvSpPr/>
              <p:nvPr/>
            </p:nvSpPr>
            <p:spPr>
              <a:xfrm>
                <a:off x="8274960" y="4881600"/>
                <a:ext cx="0" cy="13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6" name=""/>
              <p:cNvSpPr txBox="1"/>
              <p:nvPr/>
            </p:nvSpPr>
            <p:spPr>
              <a:xfrm>
                <a:off x="8274960" y="4881600"/>
                <a:ext cx="360" cy="137880"/>
              </a:xfrm>
              <a:prstGeom prst="rect">
                <a:avLst/>
              </a:prstGeom>
              <a:noFill/>
              <a:ln w="0">
                <a:noFill/>
              </a:ln>
            </p:spPr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67" name=""/>
            <p:cNvGrpSpPr/>
            <p:nvPr/>
          </p:nvGrpSpPr>
          <p:grpSpPr>
            <a:xfrm>
              <a:off x="7471080" y="4878000"/>
              <a:ext cx="360" cy="243720"/>
              <a:chOff x="7471080" y="4878000"/>
              <a:chExt cx="360" cy="243720"/>
            </a:xfrm>
          </p:grpSpPr>
          <p:sp>
            <p:nvSpPr>
              <p:cNvPr id="168" name="Line 32"/>
              <p:cNvSpPr/>
              <p:nvPr/>
            </p:nvSpPr>
            <p:spPr>
              <a:xfrm>
                <a:off x="7471080" y="4878000"/>
                <a:ext cx="0" cy="24372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9" name=""/>
              <p:cNvSpPr txBox="1"/>
              <p:nvPr/>
            </p:nvSpPr>
            <p:spPr>
              <a:xfrm>
                <a:off x="7471080" y="4878000"/>
                <a:ext cx="360" cy="243720"/>
              </a:xfrm>
              <a:prstGeom prst="rect">
                <a:avLst/>
              </a:prstGeom>
              <a:noFill/>
              <a:ln w="0">
                <a:noFill/>
              </a:ln>
            </p:spPr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70" name=""/>
            <p:cNvGrpSpPr/>
            <p:nvPr/>
          </p:nvGrpSpPr>
          <p:grpSpPr>
            <a:xfrm>
              <a:off x="7464600" y="4881600"/>
              <a:ext cx="815760" cy="360"/>
              <a:chOff x="7464600" y="4881600"/>
              <a:chExt cx="815760" cy="360"/>
            </a:xfrm>
          </p:grpSpPr>
          <p:sp>
            <p:nvSpPr>
              <p:cNvPr id="171" name="Line 33"/>
              <p:cNvSpPr/>
              <p:nvPr/>
            </p:nvSpPr>
            <p:spPr>
              <a:xfrm flipH="1">
                <a:off x="7464600" y="4881600"/>
                <a:ext cx="815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2" name=""/>
              <p:cNvSpPr txBox="1"/>
              <p:nvPr/>
            </p:nvSpPr>
            <p:spPr>
              <a:xfrm>
                <a:off x="7464960" y="4881600"/>
                <a:ext cx="815400" cy="360"/>
              </a:xfrm>
              <a:prstGeom prst="rect">
                <a:avLst/>
              </a:prstGeom>
              <a:noFill/>
              <a:ln w="0">
                <a:noFill/>
              </a:ln>
            </p:spPr>
            <p:txBody>
              <a:bodyPr lIns="90000" rIns="90000" tIns="-46440" bIns="-464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73" name=""/>
            <p:cNvGrpSpPr/>
            <p:nvPr/>
          </p:nvGrpSpPr>
          <p:grpSpPr>
            <a:xfrm>
              <a:off x="7071120" y="5045760"/>
              <a:ext cx="391320" cy="360"/>
              <a:chOff x="7071120" y="5045760"/>
              <a:chExt cx="391320" cy="360"/>
            </a:xfrm>
          </p:grpSpPr>
          <p:sp>
            <p:nvSpPr>
              <p:cNvPr id="174" name="Line 34"/>
              <p:cNvSpPr/>
              <p:nvPr/>
            </p:nvSpPr>
            <p:spPr>
              <a:xfrm>
                <a:off x="7071120" y="5045760"/>
                <a:ext cx="391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5" name=""/>
              <p:cNvSpPr txBox="1"/>
              <p:nvPr/>
            </p:nvSpPr>
            <p:spPr>
              <a:xfrm>
                <a:off x="7071120" y="5045760"/>
                <a:ext cx="391320" cy="360"/>
              </a:xfrm>
              <a:prstGeom prst="rect">
                <a:avLst/>
              </a:prstGeom>
              <a:noFill/>
              <a:ln w="0">
                <a:noFill/>
              </a:ln>
            </p:spPr>
            <p:txBody>
              <a:bodyPr lIns="90000" rIns="90000" tIns="-46440" bIns="-464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76" name="Rectangle 35"/>
            <p:cNvSpPr/>
            <p:nvPr/>
          </p:nvSpPr>
          <p:spPr>
            <a:xfrm>
              <a:off x="7746120" y="4748040"/>
              <a:ext cx="272520" cy="102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宋体"/>
                  <a:ea typeface="宋体"/>
                </a:rPr>
                <a:t>**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7" name="Rectangle 36"/>
            <p:cNvSpPr/>
            <p:nvPr/>
          </p:nvSpPr>
          <p:spPr>
            <a:xfrm>
              <a:off x="7124760" y="4905360"/>
              <a:ext cx="272520" cy="103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宋体"/>
                  <a:ea typeface="宋体"/>
                </a:rPr>
                <a:t>**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78" name="矩形 38"/>
          <p:cNvSpPr/>
          <p:nvPr/>
        </p:nvSpPr>
        <p:spPr>
          <a:xfrm>
            <a:off x="3773520" y="0"/>
            <a:ext cx="24256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Times New Roman"/>
                <a:ea typeface="宋体"/>
              </a:rPr>
              <a:t>Figure S2 apoptosis-PARP -WB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文字方塊 37"/>
          <p:cNvSpPr/>
          <p:nvPr/>
        </p:nvSpPr>
        <p:spPr>
          <a:xfrm>
            <a:off x="3815280" y="4514760"/>
            <a:ext cx="2905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文字方塊 38"/>
          <p:cNvSpPr/>
          <p:nvPr/>
        </p:nvSpPr>
        <p:spPr>
          <a:xfrm>
            <a:off x="6158520" y="4572000"/>
            <a:ext cx="2905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1" name="PlaceHolder 1"/>
          <p:cNvSpPr>
            <a:spLocks noGrp="1"/>
          </p:cNvSpPr>
          <p:nvPr>
            <p:ph type="title"/>
          </p:nvPr>
        </p:nvSpPr>
        <p:spPr>
          <a:xfrm>
            <a:off x="3695400" y="571320"/>
            <a:ext cx="4629240" cy="114300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Figure S2. Mithramycin </a:t>
            </a:r>
            <a:r>
              <a:rPr b="1" lang="en-US" sz="1800" spc="-1" strike="noStrike">
                <a:solidFill>
                  <a:srgbClr val="0000ff"/>
                </a:solidFill>
                <a:latin typeface="Times New Roman"/>
              </a:rPr>
              <a:t>blocks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 NaB induced apoptosis in colorectal cancer cells</a:t>
            </a:r>
            <a:endParaRPr b="0" lang="en-US" sz="1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82" name="Rectangle 3"/>
          <p:cNvSpPr/>
          <p:nvPr/>
        </p:nvSpPr>
        <p:spPr>
          <a:xfrm>
            <a:off x="3753000" y="1943280"/>
            <a:ext cx="4743360" cy="146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Times New Roman"/>
                <a:ea typeface="宋体"/>
              </a:rPr>
              <a:t>Representative blots showing the expression of PARP in HCT-116 or HT-29 cells that were exposed to 0.1</a:t>
            </a:r>
            <a:r>
              <a:rPr b="0" lang="de-DE" sz="1500" spc="-1" strike="noStrike">
                <a:solidFill>
                  <a:srgbClr val="000000"/>
                </a:solidFill>
                <a:latin typeface="Times New Roman"/>
                <a:ea typeface="宋体"/>
              </a:rPr>
              <a:t>μ</a:t>
            </a:r>
            <a:r>
              <a:rPr b="0" lang="en-US" sz="1500" spc="-1" strike="noStrike">
                <a:solidFill>
                  <a:srgbClr val="000000"/>
                </a:solidFill>
                <a:latin typeface="Times New Roman"/>
                <a:ea typeface="宋体"/>
              </a:rPr>
              <a:t>M Mithramycin for 30 minutes followed by treatment with 2mM NaB for 24 hours. GAPDH was used as loading control. </a:t>
            </a:r>
            <a:r>
              <a:rPr b="0" lang="en-US" sz="1500" spc="-1" strike="noStrike">
                <a:solidFill>
                  <a:srgbClr val="ff0000"/>
                </a:solidFill>
                <a:latin typeface="Times New Roman"/>
                <a:ea typeface="宋体"/>
              </a:rPr>
              <a:t>The apoptotic cells were determined by </a:t>
            </a:r>
            <a:r>
              <a:rPr b="0" lang="en-US" sz="1500" spc="-1" strike="noStrike">
                <a:solidFill>
                  <a:srgbClr val="0000ff"/>
                </a:solidFill>
                <a:latin typeface="Times New Roman"/>
                <a:ea typeface="宋体"/>
              </a:rPr>
              <a:t>the </a:t>
            </a:r>
            <a:r>
              <a:rPr b="0" lang="en-US" sz="1500" spc="-1" strike="noStrike">
                <a:solidFill>
                  <a:srgbClr val="ff0000"/>
                </a:solidFill>
                <a:latin typeface="Times New Roman"/>
                <a:ea typeface="宋体"/>
              </a:rPr>
              <a:t>Annexin V/PI assay.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1-06T02:32:00Z</dcterms:created>
  <dc:creator>Administrator</dc:creator>
  <dc:description/>
  <dc:language>en-US</dc:language>
  <cp:lastModifiedBy>Administrator</cp:lastModifiedBy>
  <dcterms:modified xsi:type="dcterms:W3CDTF">2016-01-06T03:28:05Z</dcterms:modified>
  <cp:revision>2</cp:revision>
  <dc:subject/>
  <dc:title>PowerPoint 演示文稿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5400</vt:lpwstr>
  </property>
</Properties>
</file>